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79" r:id="rId1"/>
  </p:sldMasterIdLst>
  <p:notesMasterIdLst>
    <p:notesMasterId r:id="rId7"/>
  </p:notesMasterIdLst>
  <p:handoutMasterIdLst>
    <p:handoutMasterId r:id="rId8"/>
  </p:handoutMasterIdLst>
  <p:sldIdLst>
    <p:sldId id="270" r:id="rId2"/>
    <p:sldId id="271" r:id="rId3"/>
    <p:sldId id="272" r:id="rId4"/>
    <p:sldId id="273" r:id="rId5"/>
    <p:sldId id="27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7994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20" autoAdjust="0"/>
    <p:restoredTop sz="96327" autoAdjust="0"/>
  </p:normalViewPr>
  <p:slideViewPr>
    <p:cSldViewPr snapToGrid="0">
      <p:cViewPr varScale="1">
        <p:scale>
          <a:sx n="119" d="100"/>
          <a:sy n="119" d="100"/>
        </p:scale>
        <p:origin x="832" y="18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8" d="100"/>
          <a:sy n="88" d="100"/>
        </p:scale>
        <p:origin x="3822" y="72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handoutMaster" Target="handoutMasters/handoutMaster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F9C54221-6216-4CBE-9197-64B10A20E045}" type="datetimeFigureOut">
              <a:rPr lang="en-US" smtClean="0"/>
              <a:t>3/1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1BFDD406-6C32-42CB-91D2-0E66817D17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17697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8D7118AB-EF77-4B5D-B751-8EA576DD6E10}" type="datetimeFigureOut">
              <a:rPr lang="en-US" smtClean="0"/>
              <a:t>3/1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3240CBEB-F9D1-4FDA-A046-C041E449C4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2336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40CBEB-F9D1-4FDA-A046-C041E449C48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596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AE7CC6-6643-473D-BBA9-0A243EF53BA4}" type="datetime1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165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EF7B22-D88E-4EB1-865F-43A888C52B75}" type="datetime1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495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9EA7E7-334E-4D04-A0D1-A02A316656E8}" type="datetime1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777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07858-AA34-449B-98B2-37A75FA9FE55}" type="datetime1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315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40AEC-82FB-4575-A85F-A3B2DEA88B01}" type="datetime1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28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3F31-F3C3-42A9-8D41-869F0C97C752}" type="datetime1">
              <a:rPr lang="en-US" smtClean="0"/>
              <a:t>3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6007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829BC-0827-4182-B5AE-2D358FA15FB4}" type="datetime1">
              <a:rPr lang="en-US" smtClean="0"/>
              <a:t>3/1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282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7F55E-1097-4E71-9825-D752A7936521}" type="datetime1">
              <a:rPr lang="en-US" smtClean="0"/>
              <a:t>3/1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072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2B3326-4EA7-4B51-82FA-AAC39C79A458}" type="datetime1">
              <a:rPr lang="en-US" smtClean="0"/>
              <a:t>3/1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9598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C06056-0BA9-4659-B89E-82AFF7DE6F6E}" type="datetime1">
              <a:rPr lang="en-US" smtClean="0"/>
              <a:t>3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730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D6D379-69AB-4E47-9A46-6ED1AD811C8D}" type="datetime1">
              <a:rPr lang="en-US" smtClean="0"/>
              <a:t>3/1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114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199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D2AE6-483B-4EF2-AF0A-9C86EB5917DE}" type="datetime1">
              <a:rPr lang="en-US" smtClean="0"/>
              <a:t>3/1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1DF6C4-28CE-469C-AAA7-6FCAEC44C4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236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80" r:id="rId1"/>
    <p:sldLayoutId id="2147483781" r:id="rId2"/>
    <p:sldLayoutId id="2147483782" r:id="rId3"/>
    <p:sldLayoutId id="2147483783" r:id="rId4"/>
    <p:sldLayoutId id="2147483784" r:id="rId5"/>
    <p:sldLayoutId id="2147483785" r:id="rId6"/>
    <p:sldLayoutId id="2147483786" r:id="rId7"/>
    <p:sldLayoutId id="2147483787" r:id="rId8"/>
    <p:sldLayoutId id="2147483788" r:id="rId9"/>
    <p:sldLayoutId id="2147483789" r:id="rId10"/>
    <p:sldLayoutId id="2147483790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jpeg"/><Relationship Id="rId5" Type="http://schemas.openxmlformats.org/officeDocument/2006/relationships/image" Target="../media/image8.tiff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3.tiff"/><Relationship Id="rId4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7.jpeg"/><Relationship Id="rId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7" descr="C:\Users\user\Desktop\Final WB membrane\Hippocampus\Hippocampus and cortex TAUT_40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399" y="1281591"/>
            <a:ext cx="2011680" cy="2697189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8" descr="C:\Users\user\Desktop\Final WB membrane\Hippocampus\Hippocampus and cortex beta-actin 8_18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4981" y="1281591"/>
            <a:ext cx="2011680" cy="209345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C:\Users\user\Desktop\Final WB membrane\Cortex\Hippocampus and cortex beta-actin 9_18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71891" y="1281590"/>
            <a:ext cx="2011680" cy="243930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user\Desktop\Final WB membrane\Cortex\Hippocampus and cortex TAUT_40 2tif_40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64885" y="1281590"/>
            <a:ext cx="2011680" cy="337782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TextBox 10"/>
          <p:cNvSpPr txBox="1"/>
          <p:nvPr/>
        </p:nvSpPr>
        <p:spPr>
          <a:xfrm>
            <a:off x="2280740" y="1592371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291539" y="178907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97269" y="199432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309926" y="226718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320078" y="2502726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316275" y="2784746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317969" y="3032395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322566" y="334725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263468" y="27997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272889" y="258804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5286957" y="232322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258151" y="2084544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5258151" y="1829871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258151" y="1645206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766709" y="1222970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1538456" y="1222970"/>
            <a:ext cx="75269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48" name="TextBox 2047"/>
          <p:cNvSpPr txBox="1"/>
          <p:nvPr/>
        </p:nvSpPr>
        <p:spPr>
          <a:xfrm>
            <a:off x="695764" y="906838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2049" name="TextBox 2048"/>
          <p:cNvSpPr txBox="1"/>
          <p:nvPr/>
        </p:nvSpPr>
        <p:spPr>
          <a:xfrm>
            <a:off x="1694960" y="920906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cxnSp>
        <p:nvCxnSpPr>
          <p:cNvPr id="37" name="Straight Connector 36"/>
          <p:cNvCxnSpPr/>
          <p:nvPr/>
        </p:nvCxnSpPr>
        <p:spPr>
          <a:xfrm>
            <a:off x="3636692" y="1225706"/>
            <a:ext cx="75269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4476865" y="1225706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3614028" y="909574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613224" y="923642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cxnSp>
        <p:nvCxnSpPr>
          <p:cNvPr id="41" name="Straight Connector 40"/>
          <p:cNvCxnSpPr/>
          <p:nvPr/>
        </p:nvCxnSpPr>
        <p:spPr>
          <a:xfrm>
            <a:off x="6436378" y="1227720"/>
            <a:ext cx="82796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7351166" y="1227720"/>
            <a:ext cx="82796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6424581" y="911588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7628345" y="911588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cxnSp>
        <p:nvCxnSpPr>
          <p:cNvPr id="49" name="Straight Connector 48"/>
          <p:cNvCxnSpPr/>
          <p:nvPr/>
        </p:nvCxnSpPr>
        <p:spPr>
          <a:xfrm>
            <a:off x="9541038" y="1239052"/>
            <a:ext cx="82796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10493926" y="1239052"/>
            <a:ext cx="82796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9585513" y="936988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0817413" y="936988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2052" name="TextBox 2051"/>
          <p:cNvSpPr txBox="1"/>
          <p:nvPr/>
        </p:nvSpPr>
        <p:spPr>
          <a:xfrm>
            <a:off x="2312850" y="705006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82" name="Straight Connector 81"/>
          <p:cNvCxnSpPr/>
          <p:nvPr/>
        </p:nvCxnSpPr>
        <p:spPr>
          <a:xfrm>
            <a:off x="2391516" y="1222970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3" name="TextBox 82"/>
          <p:cNvSpPr txBox="1"/>
          <p:nvPr/>
        </p:nvSpPr>
        <p:spPr>
          <a:xfrm>
            <a:off x="5262078" y="714742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84" name="Straight Connector 83"/>
          <p:cNvCxnSpPr/>
          <p:nvPr/>
        </p:nvCxnSpPr>
        <p:spPr>
          <a:xfrm>
            <a:off x="5363408" y="1207306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8226024" y="744243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88" name="Straight Connector 87"/>
          <p:cNvCxnSpPr/>
          <p:nvPr/>
        </p:nvCxnSpPr>
        <p:spPr>
          <a:xfrm>
            <a:off x="8318686" y="1238424"/>
            <a:ext cx="29019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11338487" y="757936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90" name="Straight Connector 89"/>
          <p:cNvCxnSpPr/>
          <p:nvPr/>
        </p:nvCxnSpPr>
        <p:spPr>
          <a:xfrm>
            <a:off x="11431149" y="1252117"/>
            <a:ext cx="29019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53" name="TextBox 2052"/>
          <p:cNvSpPr txBox="1"/>
          <p:nvPr/>
        </p:nvSpPr>
        <p:spPr>
          <a:xfrm>
            <a:off x="2279791" y="331960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1C</a:t>
            </a:r>
          </a:p>
        </p:txBody>
      </p:sp>
      <p:cxnSp>
        <p:nvCxnSpPr>
          <p:cNvPr id="2055" name="Straight Connector 2054"/>
          <p:cNvCxnSpPr/>
          <p:nvPr/>
        </p:nvCxnSpPr>
        <p:spPr>
          <a:xfrm>
            <a:off x="308195" y="669026"/>
            <a:ext cx="581571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4" name="TextBox 93"/>
          <p:cNvSpPr txBox="1"/>
          <p:nvPr/>
        </p:nvSpPr>
        <p:spPr>
          <a:xfrm>
            <a:off x="8247905" y="324638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1D</a:t>
            </a:r>
          </a:p>
        </p:txBody>
      </p:sp>
      <p:cxnSp>
        <p:nvCxnSpPr>
          <p:cNvPr id="95" name="Straight Connector 94"/>
          <p:cNvCxnSpPr/>
          <p:nvPr/>
        </p:nvCxnSpPr>
        <p:spPr>
          <a:xfrm>
            <a:off x="6276309" y="661704"/>
            <a:ext cx="581571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056" name="TextBox 2055"/>
          <p:cNvSpPr txBox="1"/>
          <p:nvPr/>
        </p:nvSpPr>
        <p:spPr>
          <a:xfrm>
            <a:off x="622300" y="5473700"/>
            <a:ext cx="2364750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urine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W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-20%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uperSep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gel</a:t>
            </a:r>
          </a:p>
        </p:txBody>
      </p:sp>
      <p:sp>
        <p:nvSpPr>
          <p:cNvPr id="98" name="Left Brace 97"/>
          <p:cNvSpPr/>
          <p:nvPr/>
        </p:nvSpPr>
        <p:spPr>
          <a:xfrm>
            <a:off x="505166" y="1546413"/>
            <a:ext cx="176617" cy="1143650"/>
          </a:xfrm>
          <a:prstGeom prst="lef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TextBox 98"/>
          <p:cNvSpPr txBox="1"/>
          <p:nvPr/>
        </p:nvSpPr>
        <p:spPr>
          <a:xfrm>
            <a:off x="-59008" y="1943205"/>
            <a:ext cx="626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AUT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2669399" y="2715005"/>
            <a:ext cx="9044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Beta-actin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8221683" y="1702413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8232482" y="1899119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8238212" y="210436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8250869" y="237722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8246953" y="2612768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8257218" y="2908856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8244844" y="314243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8249441" y="348543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11351017" y="302613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11360438" y="274408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111" name="TextBox 110"/>
          <p:cNvSpPr txBox="1"/>
          <p:nvPr/>
        </p:nvSpPr>
        <p:spPr>
          <a:xfrm>
            <a:off x="11374506" y="245112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12" name="TextBox 111"/>
          <p:cNvSpPr txBox="1"/>
          <p:nvPr/>
        </p:nvSpPr>
        <p:spPr>
          <a:xfrm>
            <a:off x="11345700" y="217024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113" name="TextBox 112"/>
          <p:cNvSpPr txBox="1"/>
          <p:nvPr/>
        </p:nvSpPr>
        <p:spPr>
          <a:xfrm>
            <a:off x="11345700" y="191556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114" name="TextBox 113"/>
          <p:cNvSpPr txBox="1"/>
          <p:nvPr/>
        </p:nvSpPr>
        <p:spPr>
          <a:xfrm>
            <a:off x="11345700" y="173090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sp>
        <p:nvSpPr>
          <p:cNvPr id="115" name="Left Brace 114"/>
          <p:cNvSpPr/>
          <p:nvPr/>
        </p:nvSpPr>
        <p:spPr>
          <a:xfrm>
            <a:off x="6088268" y="1702160"/>
            <a:ext cx="176617" cy="1143650"/>
          </a:xfrm>
          <a:prstGeom prst="leftBrac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TextBox 115"/>
          <p:cNvSpPr txBox="1"/>
          <p:nvPr/>
        </p:nvSpPr>
        <p:spPr>
          <a:xfrm>
            <a:off x="5580366" y="2141156"/>
            <a:ext cx="6269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TAUT</a:t>
            </a:r>
          </a:p>
        </p:txBody>
      </p:sp>
      <p:sp>
        <p:nvSpPr>
          <p:cNvPr id="117" name="TextBox 116"/>
          <p:cNvSpPr txBox="1"/>
          <p:nvPr/>
        </p:nvSpPr>
        <p:spPr>
          <a:xfrm>
            <a:off x="8580638" y="2931759"/>
            <a:ext cx="9044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Beta-actin</a:t>
            </a:r>
          </a:p>
        </p:txBody>
      </p:sp>
      <p:sp>
        <p:nvSpPr>
          <p:cNvPr id="2057" name="TextBox 2056"/>
          <p:cNvSpPr txBox="1"/>
          <p:nvPr/>
        </p:nvSpPr>
        <p:spPr>
          <a:xfrm>
            <a:off x="350418" y="3641148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119" name="TextBox 118"/>
          <p:cNvSpPr txBox="1"/>
          <p:nvPr/>
        </p:nvSpPr>
        <p:spPr>
          <a:xfrm>
            <a:off x="3274775" y="3046955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2058" name="TextBox 2057"/>
          <p:cNvSpPr txBox="1"/>
          <p:nvPr/>
        </p:nvSpPr>
        <p:spPr>
          <a:xfrm>
            <a:off x="6253494" y="434691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121" name="TextBox 120"/>
          <p:cNvSpPr txBox="1"/>
          <p:nvPr/>
        </p:nvSpPr>
        <p:spPr>
          <a:xfrm>
            <a:off x="9335012" y="339635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2060" name="TextBox 2059"/>
          <p:cNvSpPr txBox="1"/>
          <p:nvPr/>
        </p:nvSpPr>
        <p:spPr>
          <a:xfrm>
            <a:off x="449209" y="3988513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124" name="TextBox 123"/>
          <p:cNvSpPr txBox="1"/>
          <p:nvPr/>
        </p:nvSpPr>
        <p:spPr>
          <a:xfrm>
            <a:off x="6392752" y="4667734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3444052" y="3387169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126" name="TextBox 125"/>
          <p:cNvSpPr txBox="1"/>
          <p:nvPr/>
        </p:nvSpPr>
        <p:spPr>
          <a:xfrm>
            <a:off x="9630660" y="3728475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2061" name="TextBox 2060"/>
          <p:cNvSpPr txBox="1"/>
          <p:nvPr/>
        </p:nvSpPr>
        <p:spPr>
          <a:xfrm>
            <a:off x="403116" y="4757378"/>
            <a:ext cx="165462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 Indicates same gel</a:t>
            </a:r>
          </a:p>
        </p:txBody>
      </p:sp>
      <p:sp>
        <p:nvSpPr>
          <p:cNvPr id="128" name="TextBox 127"/>
          <p:cNvSpPr txBox="1"/>
          <p:nvPr/>
        </p:nvSpPr>
        <p:spPr>
          <a:xfrm>
            <a:off x="9977279" y="4869820"/>
            <a:ext cx="168026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# Indicates same gel</a:t>
            </a:r>
          </a:p>
        </p:txBody>
      </p:sp>
    </p:spTree>
    <p:extLst>
      <p:ext uri="{BB962C8B-B14F-4D97-AF65-F5344CB8AC3E}">
        <p14:creationId xmlns:p14="http://schemas.microsoft.com/office/powerpoint/2010/main" val="66085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 descr="C:\Users\user\Desktop\Final WB membrane\Hippocampus\Hippocampus PHF1  new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72037" y="772038"/>
            <a:ext cx="2011680" cy="213051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3" descr="C:\Users\user\Desktop\Final WB membrane\Hippocampus\Beta-actin _15 2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8729" y="788210"/>
            <a:ext cx="2011680" cy="257608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5" descr="C:\Users\user\Desktop\Final WB membrane\Hippocampus\Picture1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4035" y="4753804"/>
            <a:ext cx="2011680" cy="118440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4" name="Picture 2" descr="C:\Users\user\Desktop\Final WB membrane\Hippocampus\total-tau hippocampus_6_8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1979" y="799792"/>
            <a:ext cx="2011680" cy="123386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986470" y="85806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992213" y="968365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991593" y="1116458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999170" y="1243269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990272" y="141658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987739" y="157668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981290" y="1855760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986410" y="201854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pic>
        <p:nvPicPr>
          <p:cNvPr id="17" name="Picture 6" descr="C:\Users\user\Desktop\Final WB membrane\Hippocampus\Picture2.jp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12160" y="4753804"/>
            <a:ext cx="2011680" cy="115209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6236168" y="884066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227270" y="105738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224737" y="121748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218288" y="149655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6223408" y="1659343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9478470" y="1126618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9487995" y="127832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9483423" y="988178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478470" y="144758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1516009" y="731774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2287756" y="731774"/>
            <a:ext cx="75269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457764" y="428342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431560" y="455110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049450" y="277310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38" name="Straight Connector 37"/>
          <p:cNvCxnSpPr/>
          <p:nvPr/>
        </p:nvCxnSpPr>
        <p:spPr>
          <a:xfrm>
            <a:off x="3140816" y="719074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820380" y="717706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5550140" y="717706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4762135" y="414274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672431" y="428342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193800" y="1456294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584700" y="859394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7823200" y="1095528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8058880" y="755806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8788640" y="755806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8000635" y="452374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8910931" y="466442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248868" y="290388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1" name="Straight Connector 50"/>
          <p:cNvCxnSpPr/>
          <p:nvPr/>
        </p:nvCxnSpPr>
        <p:spPr>
          <a:xfrm>
            <a:off x="6340234" y="732152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9500695" y="316166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53" name="Straight Connector 52"/>
          <p:cNvCxnSpPr/>
          <p:nvPr/>
        </p:nvCxnSpPr>
        <p:spPr>
          <a:xfrm>
            <a:off x="9592061" y="757930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152400" y="1494243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805857" y="93022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HF1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804811" y="1127794"/>
            <a:ext cx="824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tal-tau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960018" y="309133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195346" y="2631386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7471946" y="175788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6226193" y="5103480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6217295" y="543368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6225041" y="571300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6211545" y="485230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cxnSp>
        <p:nvCxnSpPr>
          <p:cNvPr id="64" name="Straight Connector 63"/>
          <p:cNvCxnSpPr/>
          <p:nvPr/>
        </p:nvCxnSpPr>
        <p:spPr>
          <a:xfrm>
            <a:off x="4355919" y="473156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4313251" y="4428132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5398019" y="4454900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6241393" y="4331790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69" name="Straight Connector 68"/>
          <p:cNvCxnSpPr/>
          <p:nvPr/>
        </p:nvCxnSpPr>
        <p:spPr>
          <a:xfrm>
            <a:off x="6332759" y="4773554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5237487" y="473156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1" name="TextBox 80"/>
          <p:cNvSpPr txBox="1"/>
          <p:nvPr/>
        </p:nvSpPr>
        <p:spPr>
          <a:xfrm>
            <a:off x="3086803" y="5114775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au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7719179" y="5384895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198906" y="565805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8552588" y="565446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38332" y="70335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C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244402" y="5274658"/>
            <a:ext cx="1533305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urine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W, n=4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245075" y="3700399"/>
            <a:ext cx="334899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 Indicates same gel and 20%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erSep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gel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1237017" y="3369521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4471016" y="2908857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7699318" y="2033660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4233964" y="6381549"/>
            <a:ext cx="3510898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# Indicates same gel and 5-20%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erSep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gel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9012465" y="5928824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4651978" y="5949125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10640341" y="505647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10631443" y="538668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10639189" y="566599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10625693" y="4805294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cxnSp>
        <p:nvCxnSpPr>
          <p:cNvPr id="98" name="Straight Connector 97"/>
          <p:cNvCxnSpPr/>
          <p:nvPr/>
        </p:nvCxnSpPr>
        <p:spPr>
          <a:xfrm>
            <a:off x="8770067" y="471269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8727399" y="4409262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9812167" y="4436030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10655541" y="4284784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02" name="Straight Connector 101"/>
          <p:cNvCxnSpPr/>
          <p:nvPr/>
        </p:nvCxnSpPr>
        <p:spPr>
          <a:xfrm>
            <a:off x="10746907" y="4726548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9651635" y="471269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73443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user\Desktop\Final WB membrane\Cortex\Hippocampus and cortex beta-actin 9_18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25318" y="597525"/>
            <a:ext cx="2011680" cy="243930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C:\Users\user\Desktop\Final WB membrane\Cortex\Picture4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0551" y="4657746"/>
            <a:ext cx="2011680" cy="114856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1" name="Picture 5" descr="C:\Users\user\Desktop\Final WB membrane\Cortex\Picture5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34333" y="4666548"/>
            <a:ext cx="2011680" cy="113976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C:\Users\user\Desktop\Final WB membrane\Cortex\Picture6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32922" y="4657746"/>
            <a:ext cx="2011680" cy="101379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3" name="Picture 7" descr="C:\Users\user\Desktop\Final WB membrane\Cortex\Hippocampus and cortex PHF1 16_4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02981" y="597526"/>
            <a:ext cx="2011680" cy="277265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7202745" y="4961820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206547" y="531742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200797" y="471064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cxnSp>
        <p:nvCxnSpPr>
          <p:cNvPr id="12" name="Straight Connector 11"/>
          <p:cNvCxnSpPr/>
          <p:nvPr/>
        </p:nvCxnSpPr>
        <p:spPr>
          <a:xfrm>
            <a:off x="5363731" y="461530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321063" y="4311872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419899" y="4338640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7230645" y="4164730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6" name="Straight Connector 15"/>
          <p:cNvCxnSpPr/>
          <p:nvPr/>
        </p:nvCxnSpPr>
        <p:spPr>
          <a:xfrm>
            <a:off x="7322011" y="4606494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6245299" y="461530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210373" y="549710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713085" y="4961820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716887" y="527932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711137" y="471064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1874071" y="461530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1831403" y="4311872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930239" y="4338640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740985" y="4164730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3832351" y="4606494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755639" y="4615304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720713" y="549710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1029402" y="4857066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1020504" y="516187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1014754" y="4643986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cxnSp>
        <p:nvCxnSpPr>
          <p:cNvPr id="32" name="Straight Connector 31"/>
          <p:cNvCxnSpPr/>
          <p:nvPr/>
        </p:nvCxnSpPr>
        <p:spPr>
          <a:xfrm>
            <a:off x="9177688" y="4612150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9135020" y="4308718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10233856" y="4335486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11044602" y="4161576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11135968" y="4603340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10059256" y="4612150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1024330" y="5417749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707336" y="53951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3799998" y="548132"/>
            <a:ext cx="29019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702995" y="1027169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713794" y="1223875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719524" y="1518018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732181" y="1803579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3728265" y="206452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738530" y="2373312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726156" y="260689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7261663" y="1008910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272462" y="1205616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278192" y="1499759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290849" y="1785320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286933" y="2046265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7297198" y="235505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7284824" y="258863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759663" y="2204496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756431" y="1775789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HF1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858133" y="5204883"/>
            <a:ext cx="824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tal-tau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109303" y="5152715"/>
            <a:ext cx="1127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hospho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tau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8124215" y="5261041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cxnSp>
        <p:nvCxnSpPr>
          <p:cNvPr id="63" name="Straight Connector 62"/>
          <p:cNvCxnSpPr/>
          <p:nvPr/>
        </p:nvCxnSpPr>
        <p:spPr>
          <a:xfrm>
            <a:off x="1867006" y="548890"/>
            <a:ext cx="9107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2827714" y="548890"/>
            <a:ext cx="9107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1936076" y="245458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3050552" y="272226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7224711" y="19798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70" name="Straight Connector 69"/>
          <p:cNvCxnSpPr/>
          <p:nvPr/>
        </p:nvCxnSpPr>
        <p:spPr>
          <a:xfrm>
            <a:off x="7317373" y="513979"/>
            <a:ext cx="29019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5384381" y="542873"/>
            <a:ext cx="9107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>
            <a:off x="6345089" y="542873"/>
            <a:ext cx="9107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5453451" y="239441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6567927" y="266209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621214" y="2795904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5208242" y="3109698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708870" y="553144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5204404" y="55278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0819035" y="538809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107151" y="3349522"/>
            <a:ext cx="2390398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urine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W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-20%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uperSep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gel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3761489" y="3672688"/>
            <a:ext cx="169790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 Indicates same gel 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3808472" y="6515947"/>
            <a:ext cx="172354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# Indicates same gel 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38332" y="70335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D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1884145" y="3045957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5446687" y="3381717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5481990" y="5822513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9214017" y="5675505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1910400" y="5822513"/>
            <a:ext cx="147668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membrane</a:t>
            </a:r>
          </a:p>
        </p:txBody>
      </p:sp>
    </p:spTree>
    <p:extLst>
      <p:ext uri="{BB962C8B-B14F-4D97-AF65-F5344CB8AC3E}">
        <p14:creationId xmlns:p14="http://schemas.microsoft.com/office/powerpoint/2010/main" val="33544346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4</a:t>
            </a:fld>
            <a:endParaRPr lang="en-US"/>
          </a:p>
        </p:txBody>
      </p:sp>
      <p:pic>
        <p:nvPicPr>
          <p:cNvPr id="5122" name="Picture 2" descr="C:\Users\user\Desktop\Final WB membrane\Hippocampus\Hippocampus and cortex beta-actin 8_18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6882" y="1923899"/>
            <a:ext cx="2011680" cy="209345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3" name="Picture 3" descr="C:\Users\user\Desktop\Final WB membrane\Hippocampus\Hippocampus NeuN.ti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4866" y="1956582"/>
            <a:ext cx="2011680" cy="207484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user\Desktop\Final WB membrane\Cortex\Hippocampus and cortex beta-actin 9_18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23335" y="1769591"/>
            <a:ext cx="2011680" cy="243930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5" name="Picture 5" descr="C:\Users\user\Desktop\Final WB membrane\Cortex\Neun cortex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4147" y="1683423"/>
            <a:ext cx="2011680" cy="240736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548344" y="3418751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57765" y="319297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571833" y="2942219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543027" y="273167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543027" y="249106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543027" y="2292334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921568" y="1900970"/>
            <a:ext cx="75269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761741" y="1900970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941108" y="1584838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940304" y="1598906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532886" y="1404074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8" name="Straight Connector 17"/>
          <p:cNvCxnSpPr/>
          <p:nvPr/>
        </p:nvCxnSpPr>
        <p:spPr>
          <a:xfrm>
            <a:off x="2634216" y="1896638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531928" y="3655559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517748" y="3467158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527169" y="3227310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541237" y="2920286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512431" y="2709739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512431" y="248320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5512431" y="2270401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3890972" y="1879037"/>
            <a:ext cx="75269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4731145" y="1879037"/>
            <a:ext cx="68426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910512" y="1562905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909708" y="1576973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5502290" y="1382141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31" name="Straight Connector 30"/>
          <p:cNvCxnSpPr/>
          <p:nvPr/>
        </p:nvCxnSpPr>
        <p:spPr>
          <a:xfrm>
            <a:off x="5603620" y="1874705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5501332" y="3703966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42199" y="319952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839383" y="3337852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8606083" y="3451201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8615504" y="321135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8629572" y="2946533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600766" y="2665646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00766" y="2425041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8600766" y="2184104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cxnSp>
        <p:nvCxnSpPr>
          <p:cNvPr id="41" name="Straight Connector 40"/>
          <p:cNvCxnSpPr/>
          <p:nvPr/>
        </p:nvCxnSpPr>
        <p:spPr>
          <a:xfrm>
            <a:off x="6744720" y="1863080"/>
            <a:ext cx="82796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7635893" y="1863080"/>
            <a:ext cx="9107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6815963" y="1546948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7815159" y="1561016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8590625" y="1366184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8691955" y="1858748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8589667" y="3716145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6079575" y="3213892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8852681" y="3419750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1697070" y="3485540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1692423" y="3259760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1706491" y="2980872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1677685" y="2685917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1691753" y="237497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11691753" y="2134035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80 </a:t>
            </a:r>
          </a:p>
        </p:txBody>
      </p:sp>
      <p:cxnSp>
        <p:nvCxnSpPr>
          <p:cNvPr id="56" name="Straight Connector 55"/>
          <p:cNvCxnSpPr/>
          <p:nvPr/>
        </p:nvCxnSpPr>
        <p:spPr>
          <a:xfrm>
            <a:off x="10783152" y="1813011"/>
            <a:ext cx="9107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9906950" y="1496879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0906146" y="1510947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11681612" y="1316115"/>
            <a:ext cx="492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60" name="Straight Connector 59"/>
          <p:cNvCxnSpPr/>
          <p:nvPr/>
        </p:nvCxnSpPr>
        <p:spPr>
          <a:xfrm>
            <a:off x="11782942" y="1808679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11680654" y="3848960"/>
            <a:ext cx="3353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62" name="Straight Connector 61"/>
          <p:cNvCxnSpPr/>
          <p:nvPr/>
        </p:nvCxnSpPr>
        <p:spPr>
          <a:xfrm>
            <a:off x="9796044" y="1810663"/>
            <a:ext cx="9107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2279791" y="641456"/>
            <a:ext cx="1261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G</a:t>
            </a:r>
          </a:p>
        </p:txBody>
      </p:sp>
      <p:cxnSp>
        <p:nvCxnSpPr>
          <p:cNvPr id="64" name="Straight Connector 63"/>
          <p:cNvCxnSpPr/>
          <p:nvPr/>
        </p:nvCxnSpPr>
        <p:spPr>
          <a:xfrm>
            <a:off x="308195" y="1034794"/>
            <a:ext cx="581571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8261973" y="648202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3H</a:t>
            </a:r>
          </a:p>
        </p:txBody>
      </p:sp>
      <p:cxnSp>
        <p:nvCxnSpPr>
          <p:cNvPr id="66" name="Straight Connector 65"/>
          <p:cNvCxnSpPr/>
          <p:nvPr/>
        </p:nvCxnSpPr>
        <p:spPr>
          <a:xfrm>
            <a:off x="6346649" y="1041540"/>
            <a:ext cx="5815714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388511" y="5093954"/>
            <a:ext cx="2390398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urine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W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-20%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uperSep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gel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523910" y="3710324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3506014" y="3756826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6591126" y="37138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9714848" y="381839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786841" y="4044785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724705" y="4042437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748581" y="4090783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9796044" y="4221588"/>
            <a:ext cx="164820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ll length membrane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16160" y="4699629"/>
            <a:ext cx="169790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 Indicates same gel 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6538424" y="4816955"/>
            <a:ext cx="172354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# Indicates same gel </a:t>
            </a:r>
          </a:p>
        </p:txBody>
      </p:sp>
    </p:spTree>
    <p:extLst>
      <p:ext uri="{BB962C8B-B14F-4D97-AF65-F5344CB8AC3E}">
        <p14:creationId xmlns:p14="http://schemas.microsoft.com/office/powerpoint/2010/main" val="15260497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1DF6C4-28CE-469C-AAA7-6FCAEC44C43A}" type="slidenum">
              <a:rPr lang="en-US" smtClean="0"/>
              <a:t>5</a:t>
            </a:fld>
            <a:endParaRPr lang="en-US"/>
          </a:p>
        </p:txBody>
      </p:sp>
      <p:pic>
        <p:nvPicPr>
          <p:cNvPr id="6146" name="Picture 2" descr="C:\Users\user\Desktop\Final WB membrane\Hippocampus\Picture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1682" y="1511692"/>
            <a:ext cx="2011680" cy="11520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7" name="Picture 3" descr="C:\Users\user\Desktop\Final WB membrane\Hippocampus\Picture3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1682" y="3041645"/>
            <a:ext cx="2011680" cy="6049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8" name="Picture 4" descr="C:\Users\user\Desktop\Final WB membrane\Cortex\Picture6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7868" y="1596099"/>
            <a:ext cx="2011680" cy="101379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49" name="Picture 5" descr="C:\Users\user\Desktop\Final WB membrane\Cortex\Picture7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57868" y="3031097"/>
            <a:ext cx="2011680" cy="55506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4513388" y="1840247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503122" y="215775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497372" y="1603135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2660306" y="1493731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687978" y="1190299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786814" y="1217067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513152" y="1043157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4604518" y="1484921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3612214" y="1493731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506948" y="2361462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9419716" y="1807998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9423518" y="208330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9389632" y="1528682"/>
            <a:ext cx="44755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7580702" y="1574026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7622442" y="1270594"/>
            <a:ext cx="8173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urine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8622802" y="1297362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W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9433548" y="1123452"/>
            <a:ext cx="46679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z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kD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24" name="Straight Connector 23"/>
          <p:cNvCxnSpPr/>
          <p:nvPr/>
        </p:nvCxnSpPr>
        <p:spPr>
          <a:xfrm>
            <a:off x="9524914" y="1565216"/>
            <a:ext cx="263815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8476338" y="1574026"/>
            <a:ext cx="82796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9413276" y="2343281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40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4504600" y="313285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502252" y="3397798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9467320" y="3043685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9464972" y="3308629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631880" y="2231083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885104" y="3189380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EM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6541494" y="2196537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eta-act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808786" y="3153881"/>
            <a:ext cx="705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EM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38332" y="70335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5A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809958" y="170029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5B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388511" y="5093954"/>
            <a:ext cx="2390398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urine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W, n=4</a:t>
            </a:r>
          </a:p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5-20% </a:t>
            </a:r>
            <a:r>
              <a:rPr lang="en-US" b="1" dirty="0" err="1">
                <a:latin typeface="Arial" panose="020B0604020202020204" pitchFamily="34" charset="0"/>
                <a:cs typeface="Arial" panose="020B0604020202020204" pitchFamily="34" charset="0"/>
              </a:rPr>
              <a:t>SuperSep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 gel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291712" y="2397602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265964" y="3355329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9169466" y="32923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9229183" y="234144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#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672978" y="2628434"/>
            <a:ext cx="151515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 membrane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2344417" y="4433363"/>
            <a:ext cx="1697901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* Indicates same gel 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7468351" y="4422630"/>
            <a:ext cx="1723549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# Indicates same gel 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2825378" y="3624914"/>
            <a:ext cx="151515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 membrane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7682203" y="2579973"/>
            <a:ext cx="151515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 membrane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7682203" y="3582523"/>
            <a:ext cx="1515158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iece of  membrane</a:t>
            </a:r>
          </a:p>
        </p:txBody>
      </p:sp>
    </p:spTree>
    <p:extLst>
      <p:ext uri="{BB962C8B-B14F-4D97-AF65-F5344CB8AC3E}">
        <p14:creationId xmlns:p14="http://schemas.microsoft.com/office/powerpoint/2010/main" val="2285071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022</TotalTime>
  <Words>491</Words>
  <Application>Microsoft Macintosh PowerPoint</Application>
  <PresentationFormat>ワイド画面</PresentationFormat>
  <Paragraphs>303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isei-Koin</dc:creator>
  <cp:lastModifiedBy>Microsoft Office ユーザー</cp:lastModifiedBy>
  <cp:revision>2527</cp:revision>
  <cp:lastPrinted>2022-05-30T06:25:52Z</cp:lastPrinted>
  <dcterms:created xsi:type="dcterms:W3CDTF">2022-04-27T05:49:46Z</dcterms:created>
  <dcterms:modified xsi:type="dcterms:W3CDTF">2024-03-14T04:16:59Z</dcterms:modified>
</cp:coreProperties>
</file>